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0" r:id="rId2"/>
    <p:sldId id="256" r:id="rId3"/>
    <p:sldId id="262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49" d="100"/>
          <a:sy n="149" d="100"/>
        </p:scale>
        <p:origin x="2068" y="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5/12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12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12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12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12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12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12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12/2024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12/2024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12/2024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12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12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5/12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79512" y="5489356"/>
            <a:ext cx="720080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Shapiro et al (2024) Diabetologia DOI 10.1007/s00125-02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339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6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 </a:t>
            </a:r>
            <a:r>
              <a:rPr lang="en-GB" sz="1200" dirty="0"/>
              <a:t>The Author(s), under exclusive licence to Springer-Verlag GmbH Germany, part of Springer Nature 2024</a:t>
            </a: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/>
              <a:t>Leveraging artificial intelligence/machine learning for smarter trial design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3D895514-9419-362C-71B4-C3637DEC3AB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85272" y="908720"/>
            <a:ext cx="7026176" cy="46378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251520" y="272842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Application of artificial intelligence/machine learning to drug repurposing, development and combination therapies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5E71F7DC-FAAB-9700-D1AD-A3220F9671F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26031" y="1124744"/>
            <a:ext cx="5091937" cy="470439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FF73CEA-C801-44BC-E500-4572545B81BB}"/>
              </a:ext>
            </a:extLst>
          </p:cNvPr>
          <p:cNvSpPr txBox="1"/>
          <p:nvPr/>
        </p:nvSpPr>
        <p:spPr>
          <a:xfrm>
            <a:off x="179512" y="5489356"/>
            <a:ext cx="720080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Shapiro et al (2024) Diabetologia DOI 10.1007/s00125-02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339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6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 </a:t>
            </a:r>
            <a:r>
              <a:rPr lang="en-GB" sz="1200" dirty="0"/>
              <a:t>The Author(s), under exclusive licence to Springer-Verlag GmbH Germany, part of Springer Nature 2024</a:t>
            </a: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395536" y="332656"/>
            <a:ext cx="820891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Responder identification and potential for artificial intelligence-enabled precision medicine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F689ED58-AEA2-4993-2AAB-107B8C25778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34371" y="1260407"/>
            <a:ext cx="4075258" cy="462793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87DC8D5-708A-4E1E-51AF-2EF5C42577BE}"/>
              </a:ext>
            </a:extLst>
          </p:cNvPr>
          <p:cNvSpPr txBox="1"/>
          <p:nvPr/>
        </p:nvSpPr>
        <p:spPr>
          <a:xfrm>
            <a:off x="179512" y="5489356"/>
            <a:ext cx="720080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Shapiro et al (2024) Diabetologia DOI 10.1007/s00125-02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339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6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 </a:t>
            </a:r>
            <a:r>
              <a:rPr lang="en-GB" sz="1200" dirty="0"/>
              <a:t>The Author(s), under exclusive licence to Springer-Verlag GmbH Germany, part of Springer Nature 2024</a:t>
            </a: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559605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5</Words>
  <Application>Microsoft Office PowerPoint</Application>
  <PresentationFormat>On-screen Show (4:3)</PresentationFormat>
  <Paragraphs>16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Editorial Office</cp:lastModifiedBy>
  <cp:revision>46</cp:revision>
  <dcterms:created xsi:type="dcterms:W3CDTF">2016-06-15T12:53:43Z</dcterms:created>
  <dcterms:modified xsi:type="dcterms:W3CDTF">2024-12-05T12:44:11Z</dcterms:modified>
</cp:coreProperties>
</file>